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42"/>
    <p:restoredTop sz="94685"/>
  </p:normalViewPr>
  <p:slideViewPr>
    <p:cSldViewPr snapToGrid="0" snapToObjects="1">
      <p:cViewPr varScale="1">
        <p:scale>
          <a:sx n="142" d="100"/>
          <a:sy n="142" d="100"/>
        </p:scale>
        <p:origin x="2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9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211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804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8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18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51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9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506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31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503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66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0425" y="0"/>
            <a:ext cx="122225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 smtClean="0"/>
              <a:t>Supplementary Figure </a:t>
            </a:r>
            <a:r>
              <a:rPr lang="en-US" u="sng" dirty="0" smtClean="0"/>
              <a:t>2-</a:t>
            </a:r>
            <a:r>
              <a:rPr lang="en-US" dirty="0"/>
              <a:t> Impacts of bacterial species on fungal growth after 7 days of </a:t>
            </a:r>
            <a:r>
              <a:rPr lang="en-US" dirty="0" smtClean="0"/>
              <a:t>co-culture </a:t>
            </a:r>
            <a:r>
              <a:rPr lang="en-US" dirty="0"/>
              <a:t>on cheese curd </a:t>
            </a:r>
            <a:r>
              <a:rPr lang="en-US" smtClean="0"/>
              <a:t>agar.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-100969" y="430168"/>
            <a:ext cx="12192000" cy="6506547"/>
          </a:xfrm>
          <a:custGeom>
            <a:avLst/>
            <a:gdLst>
              <a:gd name="connsiteX0" fmla="*/ 0 w 12192000"/>
              <a:gd name="connsiteY0" fmla="*/ 0 h 6506547"/>
              <a:gd name="connsiteX1" fmla="*/ 380251 w 12192000"/>
              <a:gd name="connsiteY1" fmla="*/ 0 h 6506547"/>
              <a:gd name="connsiteX2" fmla="*/ 380251 w 12192000"/>
              <a:gd name="connsiteY2" fmla="*/ 216163 h 6506547"/>
              <a:gd name="connsiteX3" fmla="*/ 565426 w 12192000"/>
              <a:gd name="connsiteY3" fmla="*/ 216163 h 6506547"/>
              <a:gd name="connsiteX4" fmla="*/ 565426 w 12192000"/>
              <a:gd name="connsiteY4" fmla="*/ 0 h 6506547"/>
              <a:gd name="connsiteX5" fmla="*/ 12192000 w 12192000"/>
              <a:gd name="connsiteY5" fmla="*/ 0 h 6506547"/>
              <a:gd name="connsiteX6" fmla="*/ 12192000 w 12192000"/>
              <a:gd name="connsiteY6" fmla="*/ 6506547 h 6506547"/>
              <a:gd name="connsiteX7" fmla="*/ 0 w 12192000"/>
              <a:gd name="connsiteY7" fmla="*/ 6506547 h 65065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2192000" h="6506547">
                <a:moveTo>
                  <a:pt x="0" y="0"/>
                </a:moveTo>
                <a:lnTo>
                  <a:pt x="380251" y="0"/>
                </a:lnTo>
                <a:lnTo>
                  <a:pt x="380251" y="216163"/>
                </a:lnTo>
                <a:lnTo>
                  <a:pt x="565426" y="216163"/>
                </a:lnTo>
                <a:lnTo>
                  <a:pt x="565426" y="0"/>
                </a:lnTo>
                <a:lnTo>
                  <a:pt x="12192000" y="0"/>
                </a:lnTo>
                <a:lnTo>
                  <a:pt x="12192000" y="6506547"/>
                </a:lnTo>
                <a:lnTo>
                  <a:pt x="0" y="6506547"/>
                </a:lnTo>
                <a:close/>
              </a:path>
            </a:pathLst>
          </a:custGeom>
        </p:spPr>
      </p:pic>
      <p:sp>
        <p:nvSpPr>
          <p:cNvPr id="3" name="Rectangle 2"/>
          <p:cNvSpPr/>
          <p:nvPr/>
        </p:nvSpPr>
        <p:spPr>
          <a:xfrm>
            <a:off x="221225" y="430168"/>
            <a:ext cx="250489" cy="2161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706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C Pierce</dc:creator>
  <cp:lastModifiedBy>Emily C Pierce</cp:lastModifiedBy>
  <cp:revision>2</cp:revision>
  <dcterms:created xsi:type="dcterms:W3CDTF">2020-04-09T22:28:48Z</dcterms:created>
  <dcterms:modified xsi:type="dcterms:W3CDTF">2020-04-09T22:31:49Z</dcterms:modified>
</cp:coreProperties>
</file>